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2" d="100"/>
          <a:sy n="92" d="100"/>
        </p:scale>
        <p:origin x="49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E845E-9C67-4335-903A-5744282D3641}" type="datetimeFigureOut">
              <a:rPr lang="en-ZA" smtClean="0"/>
              <a:t>2019/06/1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6C7C-03D9-4593-9117-498949408EF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53718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E845E-9C67-4335-903A-5744282D3641}" type="datetimeFigureOut">
              <a:rPr lang="en-ZA" smtClean="0"/>
              <a:t>2019/06/1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6C7C-03D9-4593-9117-498949408EF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46004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E845E-9C67-4335-903A-5744282D3641}" type="datetimeFigureOut">
              <a:rPr lang="en-ZA" smtClean="0"/>
              <a:t>2019/06/1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6C7C-03D9-4593-9117-498949408EF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0133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E845E-9C67-4335-903A-5744282D3641}" type="datetimeFigureOut">
              <a:rPr lang="en-ZA" smtClean="0"/>
              <a:t>2019/06/1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6C7C-03D9-4593-9117-498949408EF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6493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E845E-9C67-4335-903A-5744282D3641}" type="datetimeFigureOut">
              <a:rPr lang="en-ZA" smtClean="0"/>
              <a:t>2019/06/1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6C7C-03D9-4593-9117-498949408EF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65968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E845E-9C67-4335-903A-5744282D3641}" type="datetimeFigureOut">
              <a:rPr lang="en-ZA" smtClean="0"/>
              <a:t>2019/06/1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6C7C-03D9-4593-9117-498949408EF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2985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E845E-9C67-4335-903A-5744282D3641}" type="datetimeFigureOut">
              <a:rPr lang="en-ZA" smtClean="0"/>
              <a:t>2019/06/14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6C7C-03D9-4593-9117-498949408EF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6912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E845E-9C67-4335-903A-5744282D3641}" type="datetimeFigureOut">
              <a:rPr lang="en-ZA" smtClean="0"/>
              <a:t>2019/06/14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6C7C-03D9-4593-9117-498949408EF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96736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E845E-9C67-4335-903A-5744282D3641}" type="datetimeFigureOut">
              <a:rPr lang="en-ZA" smtClean="0"/>
              <a:t>2019/06/14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6C7C-03D9-4593-9117-498949408EF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98719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E845E-9C67-4335-903A-5744282D3641}" type="datetimeFigureOut">
              <a:rPr lang="en-ZA" smtClean="0"/>
              <a:t>2019/06/1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6C7C-03D9-4593-9117-498949408EF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87130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BE845E-9C67-4335-903A-5744282D3641}" type="datetimeFigureOut">
              <a:rPr lang="en-ZA" smtClean="0"/>
              <a:t>2019/06/1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6C7C-03D9-4593-9117-498949408EF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15092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BE845E-9C67-4335-903A-5744282D3641}" type="datetimeFigureOut">
              <a:rPr lang="en-ZA" smtClean="0"/>
              <a:t>2019/06/1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0A6C7C-03D9-4593-9117-498949408EF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85477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 30"/>
          <p:cNvGrpSpPr/>
          <p:nvPr/>
        </p:nvGrpSpPr>
        <p:grpSpPr>
          <a:xfrm>
            <a:off x="4481162" y="475611"/>
            <a:ext cx="4384965" cy="6027622"/>
            <a:chOff x="1104116" y="83351"/>
            <a:chExt cx="4384965" cy="6027622"/>
          </a:xfrm>
        </p:grpSpPr>
        <p:cxnSp>
          <p:nvCxnSpPr>
            <p:cNvPr id="14" name="Straight Arrow Connector 13"/>
            <p:cNvCxnSpPr/>
            <p:nvPr/>
          </p:nvCxnSpPr>
          <p:spPr>
            <a:xfrm>
              <a:off x="3131457" y="2359653"/>
              <a:ext cx="0" cy="31197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8" name="Group 27"/>
            <p:cNvGrpSpPr/>
            <p:nvPr/>
          </p:nvGrpSpPr>
          <p:grpSpPr>
            <a:xfrm>
              <a:off x="1104116" y="2718084"/>
              <a:ext cx="4384965" cy="820813"/>
              <a:chOff x="1304071" y="2895017"/>
              <a:chExt cx="4384965" cy="820813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1304073" y="2982259"/>
                <a:ext cx="4384963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ZA" dirty="0" smtClean="0"/>
                  <a:t>Selection of samples with sufficient residual plasma for a second test</a:t>
                </a:r>
                <a:endParaRPr lang="en-ZA" dirty="0"/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1304071" y="2895017"/>
                <a:ext cx="4384963" cy="820813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ZA"/>
              </a:p>
            </p:txBody>
          </p:sp>
        </p:grpSp>
        <p:cxnSp>
          <p:nvCxnSpPr>
            <p:cNvPr id="17" name="Straight Arrow Connector 16"/>
            <p:cNvCxnSpPr/>
            <p:nvPr/>
          </p:nvCxnSpPr>
          <p:spPr>
            <a:xfrm>
              <a:off x="3234253" y="3595253"/>
              <a:ext cx="0" cy="27519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7" name="Group 26"/>
            <p:cNvGrpSpPr/>
            <p:nvPr/>
          </p:nvGrpSpPr>
          <p:grpSpPr>
            <a:xfrm>
              <a:off x="1548019" y="83351"/>
              <a:ext cx="3221182" cy="2276302"/>
              <a:chOff x="1548019" y="124915"/>
              <a:chExt cx="3221182" cy="2276302"/>
            </a:xfrm>
          </p:grpSpPr>
          <p:grpSp>
            <p:nvGrpSpPr>
              <p:cNvPr id="26" name="Group 25"/>
              <p:cNvGrpSpPr/>
              <p:nvPr/>
            </p:nvGrpSpPr>
            <p:grpSpPr>
              <a:xfrm>
                <a:off x="1548019" y="124915"/>
                <a:ext cx="3221182" cy="1624509"/>
                <a:chOff x="1564782" y="418463"/>
                <a:chExt cx="3221182" cy="1624509"/>
              </a:xfrm>
            </p:grpSpPr>
            <p:grpSp>
              <p:nvGrpSpPr>
                <p:cNvPr id="25" name="Group 24"/>
                <p:cNvGrpSpPr/>
                <p:nvPr/>
              </p:nvGrpSpPr>
              <p:grpSpPr>
                <a:xfrm>
                  <a:off x="1564782" y="418463"/>
                  <a:ext cx="3221182" cy="758536"/>
                  <a:chOff x="1564782" y="418463"/>
                  <a:chExt cx="3221182" cy="758536"/>
                </a:xfrm>
              </p:grpSpPr>
              <p:sp>
                <p:nvSpPr>
                  <p:cNvPr id="2" name="Rectangle 1"/>
                  <p:cNvSpPr/>
                  <p:nvPr/>
                </p:nvSpPr>
                <p:spPr>
                  <a:xfrm>
                    <a:off x="1564782" y="418463"/>
                    <a:ext cx="3221182" cy="758536"/>
                  </a:xfrm>
                  <a:prstGeom prst="rect">
                    <a:avLst/>
                  </a:prstGeom>
                  <a:noFill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ZA"/>
                  </a:p>
                </p:txBody>
              </p:sp>
              <p:sp>
                <p:nvSpPr>
                  <p:cNvPr id="3" name="TextBox 2"/>
                  <p:cNvSpPr txBox="1"/>
                  <p:nvPr/>
                </p:nvSpPr>
                <p:spPr>
                  <a:xfrm>
                    <a:off x="1805895" y="669054"/>
                    <a:ext cx="2738955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ZA" dirty="0" smtClean="0"/>
                      <a:t>Routine diagnostic samples</a:t>
                    </a:r>
                    <a:endParaRPr lang="en-ZA" dirty="0"/>
                  </a:p>
                </p:txBody>
              </p:sp>
            </p:grpSp>
            <p:cxnSp>
              <p:nvCxnSpPr>
                <p:cNvPr id="5" name="Straight Arrow Connector 4"/>
                <p:cNvCxnSpPr/>
                <p:nvPr/>
              </p:nvCxnSpPr>
              <p:spPr>
                <a:xfrm flipH="1">
                  <a:off x="3065317" y="1347287"/>
                  <a:ext cx="1" cy="249382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" name="TextBox 5"/>
                <p:cNvSpPr txBox="1"/>
                <p:nvPr/>
              </p:nvSpPr>
              <p:spPr>
                <a:xfrm>
                  <a:off x="1849580" y="1673640"/>
                  <a:ext cx="284710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ZA" dirty="0"/>
                    <a:t>RCF </a:t>
                  </a:r>
                  <a:r>
                    <a:rPr lang="en-ZA" dirty="0" smtClean="0"/>
                    <a:t>3,273g </a:t>
                  </a:r>
                  <a:r>
                    <a:rPr lang="en-ZA" dirty="0"/>
                    <a:t>for 10 minutes</a:t>
                  </a:r>
                  <a:endParaRPr lang="en-US" dirty="0"/>
                </a:p>
              </p:txBody>
            </p:sp>
          </p:grpSp>
          <p:sp>
            <p:nvSpPr>
              <p:cNvPr id="8" name="TextBox 7"/>
              <p:cNvSpPr txBox="1"/>
              <p:nvPr/>
            </p:nvSpPr>
            <p:spPr>
              <a:xfrm>
                <a:off x="2344343" y="2031885"/>
                <a:ext cx="16620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ZA" dirty="0" smtClean="0"/>
                  <a:t>Viral load Test 1</a:t>
                </a:r>
                <a:endParaRPr lang="en-ZA" dirty="0"/>
              </a:p>
            </p:txBody>
          </p:sp>
          <p:cxnSp>
            <p:nvCxnSpPr>
              <p:cNvPr id="19" name="Straight Arrow Connector 18"/>
              <p:cNvCxnSpPr/>
              <p:nvPr/>
            </p:nvCxnSpPr>
            <p:spPr>
              <a:xfrm>
                <a:off x="3104531" y="1928671"/>
                <a:ext cx="0" cy="170738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 29"/>
            <p:cNvGrpSpPr/>
            <p:nvPr/>
          </p:nvGrpSpPr>
          <p:grpSpPr>
            <a:xfrm>
              <a:off x="1810974" y="3976440"/>
              <a:ext cx="3077961" cy="2134533"/>
              <a:chOff x="1810974" y="3976440"/>
              <a:chExt cx="3077961" cy="2134533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2041826" y="5023832"/>
                <a:ext cx="284710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ZA" dirty="0"/>
                  <a:t>RCF 3,273g for 10 minutes</a:t>
                </a:r>
                <a:endParaRPr lang="en-US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2492495" y="5741641"/>
                <a:ext cx="16620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ZA" dirty="0" smtClean="0"/>
                  <a:t>Viral load Test 2</a:t>
                </a:r>
                <a:endParaRPr lang="en-ZA" dirty="0"/>
              </a:p>
            </p:txBody>
          </p:sp>
          <p:cxnSp>
            <p:nvCxnSpPr>
              <p:cNvPr id="22" name="Straight Arrow Connector 21"/>
              <p:cNvCxnSpPr/>
              <p:nvPr/>
            </p:nvCxnSpPr>
            <p:spPr>
              <a:xfrm>
                <a:off x="3296597" y="4667711"/>
                <a:ext cx="0" cy="275193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9" name="Group 28"/>
              <p:cNvGrpSpPr/>
              <p:nvPr/>
            </p:nvGrpSpPr>
            <p:grpSpPr>
              <a:xfrm>
                <a:off x="1810974" y="3976440"/>
                <a:ext cx="2890794" cy="923330"/>
                <a:chOff x="1805895" y="4140611"/>
                <a:chExt cx="2890794" cy="923330"/>
              </a:xfrm>
            </p:grpSpPr>
            <p:sp>
              <p:nvSpPr>
                <p:cNvPr id="10" name="TextBox 9"/>
                <p:cNvSpPr txBox="1"/>
                <p:nvPr/>
              </p:nvSpPr>
              <p:spPr>
                <a:xfrm>
                  <a:off x="1849580" y="4140611"/>
                  <a:ext cx="2795125" cy="9233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ZA" dirty="0"/>
                    <a:t>Storage at 4</a:t>
                  </a:r>
                  <a:r>
                    <a:rPr lang="en-ZA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°C</a:t>
                  </a:r>
                  <a:r>
                    <a:rPr lang="en-ZA" dirty="0"/>
                    <a:t>, 20°C or 30°C</a:t>
                  </a:r>
                </a:p>
                <a:p>
                  <a:pPr algn="ctr"/>
                  <a:r>
                    <a:rPr lang="en-ZA" dirty="0"/>
                    <a:t>For 72, 96 or 168 hours</a:t>
                  </a:r>
                  <a:endParaRPr lang="en-US" dirty="0"/>
                </a:p>
                <a:p>
                  <a:pPr algn="ctr"/>
                  <a:r>
                    <a:rPr lang="en-ZA" dirty="0" smtClean="0"/>
                    <a:t> </a:t>
                  </a:r>
                  <a:endParaRPr lang="en-ZA" dirty="0"/>
                </a:p>
              </p:txBody>
            </p:sp>
            <p:sp>
              <p:nvSpPr>
                <p:cNvPr id="23" name="Rectangle 22"/>
                <p:cNvSpPr/>
                <p:nvPr/>
              </p:nvSpPr>
              <p:spPr>
                <a:xfrm>
                  <a:off x="1805895" y="4156363"/>
                  <a:ext cx="2890794" cy="633846"/>
                </a:xfrm>
                <a:prstGeom prst="rect">
                  <a:avLst/>
                </a:pr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ZA"/>
                </a:p>
              </p:txBody>
            </p:sp>
          </p:grpSp>
          <p:cxnSp>
            <p:nvCxnSpPr>
              <p:cNvPr id="24" name="Straight Arrow Connector 23"/>
              <p:cNvCxnSpPr/>
              <p:nvPr/>
            </p:nvCxnSpPr>
            <p:spPr>
              <a:xfrm>
                <a:off x="3295032" y="5393164"/>
                <a:ext cx="0" cy="275193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2" name="TextBox 31"/>
          <p:cNvSpPr txBox="1"/>
          <p:nvPr/>
        </p:nvSpPr>
        <p:spPr>
          <a:xfrm>
            <a:off x="654627" y="683923"/>
            <a:ext cx="1263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b="1" dirty="0" smtClean="0"/>
              <a:t>Study plan:</a:t>
            </a:r>
            <a:endParaRPr lang="en-ZA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685800" y="290945"/>
            <a:ext cx="6928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 smtClean="0"/>
              <a:t>S1 fig</a:t>
            </a:r>
            <a:endParaRPr lang="en-ZA" dirty="0"/>
          </a:p>
        </p:txBody>
      </p:sp>
      <p:cxnSp>
        <p:nvCxnSpPr>
          <p:cNvPr id="35" name="Straight Arrow Connector 34"/>
          <p:cNvCxnSpPr/>
          <p:nvPr/>
        </p:nvCxnSpPr>
        <p:spPr>
          <a:xfrm>
            <a:off x="7531599" y="2567247"/>
            <a:ext cx="3735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8053285" y="2378422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 smtClean="0"/>
              <a:t>Clinical result released</a:t>
            </a:r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10058774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55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9</cp:revision>
  <dcterms:created xsi:type="dcterms:W3CDTF">2019-03-22T09:10:44Z</dcterms:created>
  <dcterms:modified xsi:type="dcterms:W3CDTF">2019-06-14T10:27:35Z</dcterms:modified>
</cp:coreProperties>
</file>